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75787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8" d="100"/>
          <a:sy n="98" d="100"/>
        </p:scale>
        <p:origin x="103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J:\SSR41data\&#24352;&#21321;&#25910;&#23614;&#20219;&#21153;\&#24050;&#23436;&#25104;-&#24352;&#21321;&#25910;&#23614;&#20219;&#21153;20210705\&#20219;&#21153;1&#22270;&#29255;&#23436;&#21892;\&#38124;&#22788;&#29702;&#26681;&#38271;&#21644;&#33495;&#38271;&#25968;&#25454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J:\SSR41data\&#24352;&#21321;&#25910;&#23614;&#20219;&#21153;\&#24050;&#23436;&#25104;-&#24352;&#21321;&#25910;&#23614;&#20219;&#21153;20210705\&#20219;&#21153;1&#22270;&#29255;&#23436;&#21892;\&#38124;&#22788;&#29702;&#26681;&#38271;&#21644;&#33495;&#38271;&#25968;&#25454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163383491654292"/>
          <c:y val="8.3838594249792855E-2"/>
          <c:w val="0.71841204456349639"/>
          <c:h val="0.781996077650787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苗长作图 (2)'!$P$2</c:f>
              <c:strCache>
                <c:ptCount val="1"/>
                <c:pt idx="0">
                  <c:v>Yugu1</c:v>
                </c:pt>
              </c:strCache>
            </c:strRef>
          </c:tx>
          <c:spPr>
            <a:solidFill>
              <a:srgbClr val="0070C0"/>
            </a:solidFill>
            <a:ln w="12700">
              <a:solidFill>
                <a:schemeClr val="bg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/>
              </a:soli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682-41EA-93F3-67F42EA4E1FE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/>
              </a:soli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682-41EA-93F3-67F42EA4E1FE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1"/>
              </a:soli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682-41EA-93F3-67F42EA4E1FE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1"/>
              </a:soli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682-41EA-93F3-67F42EA4E1FE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1"/>
              </a:solidFill>
              <a:ln w="12700">
                <a:solidFill>
                  <a:schemeClr val="bg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9682-41EA-93F3-67F42EA4E1FE}"/>
              </c:ext>
            </c:extLst>
          </c:dPt>
          <c:errBars>
            <c:errBarType val="both"/>
            <c:errValType val="cust"/>
            <c:noEndCap val="0"/>
            <c:plus>
              <c:numRef>
                <c:f>'苗长作图 (2)'!$X$10:$X$14</c:f>
                <c:numCache>
                  <c:formatCode>General</c:formatCode>
                  <c:ptCount val="5"/>
                  <c:pt idx="0">
                    <c:v>0.14335014721262881</c:v>
                  </c:pt>
                  <c:pt idx="1">
                    <c:v>0.11537087830314698</c:v>
                  </c:pt>
                  <c:pt idx="2">
                    <c:v>8.8934564288279963E-2</c:v>
                  </c:pt>
                  <c:pt idx="3">
                    <c:v>0.12650273189330966</c:v>
                  </c:pt>
                  <c:pt idx="4">
                    <c:v>0.13857450969367385</c:v>
                  </c:pt>
                </c:numCache>
              </c:numRef>
            </c:plus>
            <c:minus>
              <c:numRef>
                <c:f>'苗长作图 (2)'!$X$10:$X$14</c:f>
                <c:numCache>
                  <c:formatCode>General</c:formatCode>
                  <c:ptCount val="5"/>
                  <c:pt idx="0">
                    <c:v>0.14335014721262881</c:v>
                  </c:pt>
                  <c:pt idx="1">
                    <c:v>0.11537087830314698</c:v>
                  </c:pt>
                  <c:pt idx="2">
                    <c:v>8.8934564288279963E-2</c:v>
                  </c:pt>
                  <c:pt idx="3">
                    <c:v>0.12650273189330966</c:v>
                  </c:pt>
                  <c:pt idx="4">
                    <c:v>0.1385745096936738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苗长作图 (2)'!$O$3:$O$7</c:f>
              <c:strCache>
                <c:ptCount val="5"/>
                <c:pt idx="0">
                  <c:v>0uM</c:v>
                </c:pt>
                <c:pt idx="1">
                  <c:v>5uM</c:v>
                </c:pt>
                <c:pt idx="2">
                  <c:v>15uM</c:v>
                </c:pt>
                <c:pt idx="3">
                  <c:v>30uM</c:v>
                </c:pt>
                <c:pt idx="4">
                  <c:v>60uM</c:v>
                </c:pt>
              </c:strCache>
            </c:strRef>
          </c:cat>
          <c:val>
            <c:numRef>
              <c:f>'苗长作图 (2)'!$P$3:$P$7</c:f>
              <c:numCache>
                <c:formatCode>0.000_ </c:formatCode>
                <c:ptCount val="5"/>
                <c:pt idx="0">
                  <c:v>1.6135294117647057</c:v>
                </c:pt>
                <c:pt idx="1">
                  <c:v>1.6625000000000003</c:v>
                </c:pt>
                <c:pt idx="2">
                  <c:v>1.5473684210526315</c:v>
                </c:pt>
                <c:pt idx="3">
                  <c:v>1.5249999999999997</c:v>
                </c:pt>
                <c:pt idx="4">
                  <c:v>1.4484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9682-41EA-93F3-67F42EA4E1FE}"/>
            </c:ext>
          </c:extLst>
        </c:ser>
        <c:ser>
          <c:idx val="1"/>
          <c:order val="1"/>
          <c:tx>
            <c:strRef>
              <c:f>'苗长作图 (2)'!$Q$2</c:f>
              <c:strCache>
                <c:ptCount val="1"/>
                <c:pt idx="0">
                  <c:v>siwls1</c:v>
                </c:pt>
              </c:strCache>
            </c:strRef>
          </c:tx>
          <c:spPr>
            <a:solidFill>
              <a:schemeClr val="accent6"/>
            </a:solidFill>
            <a:ln w="12700">
              <a:solidFill>
                <a:schemeClr val="bg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苗长作图 (2)'!$Y$10:$Y$14</c:f>
                <c:numCache>
                  <c:formatCode>General</c:formatCode>
                  <c:ptCount val="5"/>
                  <c:pt idx="0">
                    <c:v>0.18641746320620026</c:v>
                  </c:pt>
                  <c:pt idx="1">
                    <c:v>0.13803127029389886</c:v>
                  </c:pt>
                  <c:pt idx="2">
                    <c:v>0.13098412921137872</c:v>
                  </c:pt>
                  <c:pt idx="3">
                    <c:v>0.18086574662067387</c:v>
                  </c:pt>
                  <c:pt idx="4">
                    <c:v>0.18202082009311132</c:v>
                  </c:pt>
                </c:numCache>
              </c:numRef>
            </c:plus>
            <c:minus>
              <c:numRef>
                <c:f>'苗长作图 (2)'!$Y$10:$Y$14</c:f>
                <c:numCache>
                  <c:formatCode>General</c:formatCode>
                  <c:ptCount val="5"/>
                  <c:pt idx="0">
                    <c:v>0.18641746320620026</c:v>
                  </c:pt>
                  <c:pt idx="1">
                    <c:v>0.13803127029389886</c:v>
                  </c:pt>
                  <c:pt idx="2">
                    <c:v>0.13098412921137872</c:v>
                  </c:pt>
                  <c:pt idx="3">
                    <c:v>0.18086574662067387</c:v>
                  </c:pt>
                  <c:pt idx="4">
                    <c:v>0.1820208200931113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苗长作图 (2)'!$O$3:$O$7</c:f>
              <c:strCache>
                <c:ptCount val="5"/>
                <c:pt idx="0">
                  <c:v>0uM</c:v>
                </c:pt>
                <c:pt idx="1">
                  <c:v>5uM</c:v>
                </c:pt>
                <c:pt idx="2">
                  <c:v>15uM</c:v>
                </c:pt>
                <c:pt idx="3">
                  <c:v>30uM</c:v>
                </c:pt>
                <c:pt idx="4">
                  <c:v>60uM</c:v>
                </c:pt>
              </c:strCache>
            </c:strRef>
          </c:cat>
          <c:val>
            <c:numRef>
              <c:f>'苗长作图 (2)'!$Q$3:$Q$7</c:f>
              <c:numCache>
                <c:formatCode>0.000_ </c:formatCode>
                <c:ptCount val="5"/>
                <c:pt idx="0">
                  <c:v>1.61375</c:v>
                </c:pt>
                <c:pt idx="1">
                  <c:v>1.48</c:v>
                </c:pt>
                <c:pt idx="2">
                  <c:v>1.3844444444444446</c:v>
                </c:pt>
                <c:pt idx="3">
                  <c:v>1.3222222222222222</c:v>
                </c:pt>
                <c:pt idx="4">
                  <c:v>1.304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9682-41EA-93F3-67F42EA4E1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5"/>
        <c:axId val="531864888"/>
        <c:axId val="531865672"/>
      </c:barChart>
      <c:catAx>
        <c:axId val="5318648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531865672"/>
        <c:crossesAt val="0"/>
        <c:auto val="1"/>
        <c:lblAlgn val="ctr"/>
        <c:lblOffset val="100"/>
        <c:noMultiLvlLbl val="0"/>
      </c:catAx>
      <c:valAx>
        <c:axId val="531865672"/>
        <c:scaling>
          <c:orientation val="minMax"/>
          <c:min val="0"/>
        </c:scaling>
        <c:delete val="0"/>
        <c:axPos val="l"/>
        <c:numFmt formatCode="0.0_ 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531864888"/>
        <c:crosses val="autoZero"/>
        <c:crossBetween val="between"/>
        <c:majorUnit val="0.5"/>
        <c:minorUnit val="0.2"/>
      </c:valAx>
      <c:spPr>
        <a:noFill/>
        <a:ln w="12700" cap="sq">
          <a:solidFill>
            <a:sysClr val="windowText" lastClr="000000"/>
          </a:solidFill>
        </a:ln>
        <a:effectLst/>
      </c:spPr>
    </c:plotArea>
    <c:legend>
      <c:legendPos val="r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</c:legendEntry>
      <c:layout>
        <c:manualLayout>
          <c:xMode val="edge"/>
          <c:yMode val="edge"/>
          <c:x val="0.71970129178692532"/>
          <c:y val="0.10569635585675248"/>
          <c:w val="0.13161017916238732"/>
          <c:h val="0.1126148407249381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8163383491654292"/>
          <c:y val="8.3838594249792855E-2"/>
          <c:w val="0.71841204456349639"/>
          <c:h val="0.781996077650787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根长作图!$T$2</c:f>
              <c:strCache>
                <c:ptCount val="1"/>
                <c:pt idx="0">
                  <c:v>Yugu1</c:v>
                </c:pt>
              </c:strCache>
            </c:strRef>
          </c:tx>
          <c:spPr>
            <a:solidFill>
              <a:schemeClr val="accent1"/>
            </a:solidFill>
            <a:ln w="12700">
              <a:noFill/>
            </a:ln>
            <a:effectLst>
              <a:glow>
                <a:schemeClr val="accent1">
                  <a:alpha val="40000"/>
                </a:schemeClr>
              </a:glow>
              <a:outerShdw blurRad="50800" dist="50800" dir="5400000" sx="1000" sy="1000" algn="ctr" rotWithShape="0">
                <a:srgbClr val="000000">
                  <a:alpha val="43137"/>
                </a:srgbClr>
              </a:outerShdw>
            </a:effectLst>
          </c:spPr>
          <c:invertIfNegative val="0"/>
          <c:errBars>
            <c:errBarType val="both"/>
            <c:errValType val="cust"/>
            <c:noEndCap val="0"/>
            <c:plus>
              <c:numRef>
                <c:f>根长作图!$X$10:$X$14</c:f>
                <c:numCache>
                  <c:formatCode>General</c:formatCode>
                  <c:ptCount val="5"/>
                  <c:pt idx="0">
                    <c:v>0.88071068790464235</c:v>
                  </c:pt>
                  <c:pt idx="1">
                    <c:v>0.37793321696235554</c:v>
                  </c:pt>
                  <c:pt idx="2">
                    <c:v>0.4751384839679596</c:v>
                  </c:pt>
                  <c:pt idx="3">
                    <c:v>0.31783838948444754</c:v>
                  </c:pt>
                  <c:pt idx="4">
                    <c:v>0.27119375477982438</c:v>
                  </c:pt>
                </c:numCache>
              </c:numRef>
            </c:plus>
            <c:minus>
              <c:numRef>
                <c:f>根长作图!$X$10:$X$14</c:f>
                <c:numCache>
                  <c:formatCode>General</c:formatCode>
                  <c:ptCount val="5"/>
                  <c:pt idx="0">
                    <c:v>0.88071068790464235</c:v>
                  </c:pt>
                  <c:pt idx="1">
                    <c:v>0.37793321696235554</c:v>
                  </c:pt>
                  <c:pt idx="2">
                    <c:v>0.4751384839679596</c:v>
                  </c:pt>
                  <c:pt idx="3">
                    <c:v>0.31783838948444754</c:v>
                  </c:pt>
                  <c:pt idx="4">
                    <c:v>0.2711937547798243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根长作图!$S$3:$S$7</c:f>
              <c:strCache>
                <c:ptCount val="5"/>
                <c:pt idx="0">
                  <c:v>0uM</c:v>
                </c:pt>
                <c:pt idx="1">
                  <c:v>5uM</c:v>
                </c:pt>
                <c:pt idx="2">
                  <c:v>15uM</c:v>
                </c:pt>
                <c:pt idx="3">
                  <c:v>30uM</c:v>
                </c:pt>
                <c:pt idx="4">
                  <c:v>60uM</c:v>
                </c:pt>
              </c:strCache>
            </c:strRef>
          </c:cat>
          <c:val>
            <c:numRef>
              <c:f>根长作图!$T$3:$T$7</c:f>
              <c:numCache>
                <c:formatCode>0.000_ </c:formatCode>
                <c:ptCount val="5"/>
                <c:pt idx="0" formatCode="General">
                  <c:v>3.3275000000000006</c:v>
                </c:pt>
                <c:pt idx="1">
                  <c:v>3.297857142857143</c:v>
                </c:pt>
                <c:pt idx="2">
                  <c:v>3.0042105263157897</c:v>
                </c:pt>
                <c:pt idx="3">
                  <c:v>2.5027777777777778</c:v>
                </c:pt>
                <c:pt idx="4">
                  <c:v>1.8775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21F-40B8-83E4-D691BE137CFE}"/>
            </c:ext>
          </c:extLst>
        </c:ser>
        <c:ser>
          <c:idx val="1"/>
          <c:order val="1"/>
          <c:tx>
            <c:strRef>
              <c:f>根长作图!$U$2</c:f>
              <c:strCache>
                <c:ptCount val="1"/>
                <c:pt idx="0">
                  <c:v>siwls1</c:v>
                </c:pt>
              </c:strCache>
            </c:strRef>
          </c:tx>
          <c:spPr>
            <a:solidFill>
              <a:schemeClr val="accent6"/>
            </a:solidFill>
            <a:ln w="12700"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根长作图!$Y$10:$Y$14</c:f>
                <c:numCache>
                  <c:formatCode>General</c:formatCode>
                  <c:ptCount val="5"/>
                  <c:pt idx="0">
                    <c:v>0.81742535471216771</c:v>
                  </c:pt>
                  <c:pt idx="1">
                    <c:v>0.68414295212869558</c:v>
                  </c:pt>
                  <c:pt idx="2">
                    <c:v>0.33624256769107025</c:v>
                  </c:pt>
                  <c:pt idx="3">
                    <c:v>0.33442224102789136</c:v>
                  </c:pt>
                  <c:pt idx="4">
                    <c:v>0.41010268290553298</c:v>
                  </c:pt>
                </c:numCache>
              </c:numRef>
            </c:plus>
            <c:minus>
              <c:numRef>
                <c:f>根长作图!$Y$10:$Y$14</c:f>
                <c:numCache>
                  <c:formatCode>General</c:formatCode>
                  <c:ptCount val="5"/>
                  <c:pt idx="0">
                    <c:v>0.81742535471216771</c:v>
                  </c:pt>
                  <c:pt idx="1">
                    <c:v>0.68414295212869558</c:v>
                  </c:pt>
                  <c:pt idx="2">
                    <c:v>0.33624256769107025</c:v>
                  </c:pt>
                  <c:pt idx="3">
                    <c:v>0.33442224102789136</c:v>
                  </c:pt>
                  <c:pt idx="4">
                    <c:v>0.4101026829055329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根长作图!$S$3:$S$7</c:f>
              <c:strCache>
                <c:ptCount val="5"/>
                <c:pt idx="0">
                  <c:v>0uM</c:v>
                </c:pt>
                <c:pt idx="1">
                  <c:v>5uM</c:v>
                </c:pt>
                <c:pt idx="2">
                  <c:v>15uM</c:v>
                </c:pt>
                <c:pt idx="3">
                  <c:v>30uM</c:v>
                </c:pt>
                <c:pt idx="4">
                  <c:v>60uM</c:v>
                </c:pt>
              </c:strCache>
            </c:strRef>
          </c:cat>
          <c:val>
            <c:numRef>
              <c:f>根长作图!$U$3:$U$7</c:f>
              <c:numCache>
                <c:formatCode>0.000_ </c:formatCode>
                <c:ptCount val="5"/>
                <c:pt idx="0" formatCode="General">
                  <c:v>3.2149999999999999</c:v>
                </c:pt>
                <c:pt idx="1">
                  <c:v>2.8109999999999999</c:v>
                </c:pt>
                <c:pt idx="2">
                  <c:v>2.4694444444444441</c:v>
                </c:pt>
                <c:pt idx="3">
                  <c:v>1.8250000000000002</c:v>
                </c:pt>
                <c:pt idx="4">
                  <c:v>1.215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21F-40B8-83E4-D691BE137C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5"/>
        <c:axId val="531863712"/>
        <c:axId val="531870768"/>
      </c:barChart>
      <c:catAx>
        <c:axId val="531863712"/>
        <c:scaling>
          <c:orientation val="minMax"/>
        </c:scaling>
        <c:delete val="0"/>
        <c:axPos val="b"/>
        <c:numFmt formatCode="General" sourceLinked="1"/>
        <c:majorTickMark val="out"/>
        <c:minorTickMark val="out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531870768"/>
        <c:crossesAt val="0"/>
        <c:auto val="1"/>
        <c:lblAlgn val="ctr"/>
        <c:lblOffset val="100"/>
        <c:noMultiLvlLbl val="0"/>
      </c:catAx>
      <c:valAx>
        <c:axId val="531870768"/>
        <c:scaling>
          <c:orientation val="minMax"/>
          <c:max val="5"/>
          <c:min val="0"/>
        </c:scaling>
        <c:delete val="0"/>
        <c:axPos val="l"/>
        <c:numFmt formatCode="0.0_ " sourceLinked="0"/>
        <c:majorTickMark val="in"/>
        <c:minorTickMark val="in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531863712"/>
        <c:crosses val="autoZero"/>
        <c:crossBetween val="between"/>
        <c:majorUnit val="1"/>
        <c:minorUnit val="1"/>
      </c:valAx>
      <c:spPr>
        <a:noFill/>
        <a:ln w="12700" cap="sq">
          <a:solidFill>
            <a:schemeClr val="tx1"/>
          </a:solidFill>
        </a:ln>
        <a:effectLst/>
      </c:spPr>
    </c:plotArea>
    <c:legend>
      <c:legendPos val="r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12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</c:legendEntry>
      <c:layout>
        <c:manualLayout>
          <c:xMode val="edge"/>
          <c:yMode val="edge"/>
          <c:x val="0.71970129178692532"/>
          <c:y val="0.10569635585675248"/>
          <c:w val="0.13161017916238732"/>
          <c:h val="0.1126148407249381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240315"/>
            <a:ext cx="9144000" cy="2638519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980586"/>
            <a:ext cx="9144000" cy="1829770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72511-65D0-4A52-AA9F-160CFDD4F344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DA816-E5E5-493B-AC71-5BB70D95397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72511-65D0-4A52-AA9F-160CFDD4F344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DA816-E5E5-493B-AC71-5BB70D95397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403497"/>
            <a:ext cx="2628900" cy="642261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403497"/>
            <a:ext cx="7734300" cy="642261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72511-65D0-4A52-AA9F-160CFDD4F344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DA816-E5E5-493B-AC71-5BB70D95397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72511-65D0-4A52-AA9F-160CFDD4F344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DA816-E5E5-493B-AC71-5BB70D95397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889419"/>
            <a:ext cx="10515600" cy="315253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5071782"/>
            <a:ext cx="10515600" cy="1657846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72511-65D0-4A52-AA9F-160CFDD4F344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DA816-E5E5-493B-AC71-5BB70D95397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017485"/>
            <a:ext cx="5181600" cy="480863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017485"/>
            <a:ext cx="5181600" cy="480863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72511-65D0-4A52-AA9F-160CFDD4F344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DA816-E5E5-493B-AC71-5BB70D95397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03497"/>
            <a:ext cx="10515600" cy="146487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857841"/>
            <a:ext cx="5157787" cy="91049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768340"/>
            <a:ext cx="5157787" cy="407181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857841"/>
            <a:ext cx="5183188" cy="91049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768340"/>
            <a:ext cx="5183188" cy="407181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72511-65D0-4A52-AA9F-160CFDD4F344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DA816-E5E5-493B-AC71-5BB70D95397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72511-65D0-4A52-AA9F-160CFDD4F344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DA816-E5E5-493B-AC71-5BB70D95397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72511-65D0-4A52-AA9F-160CFDD4F344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DA816-E5E5-493B-AC71-5BB70D95397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505248"/>
            <a:ext cx="3932237" cy="1768369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091197"/>
            <a:ext cx="6172200" cy="538580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273617"/>
            <a:ext cx="3932237" cy="421215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72511-65D0-4A52-AA9F-160CFDD4F344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DA816-E5E5-493B-AC71-5BB70D95397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505248"/>
            <a:ext cx="3932237" cy="1768369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091197"/>
            <a:ext cx="6172200" cy="5385807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9" y="2273617"/>
            <a:ext cx="3932237" cy="421215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E72511-65D0-4A52-AA9F-160CFDD4F344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0DA816-E5E5-493B-AC71-5BB70D95397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03497"/>
            <a:ext cx="10515600" cy="146487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017485"/>
            <a:ext cx="10515600" cy="48086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7024356"/>
            <a:ext cx="2743200" cy="4034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E72511-65D0-4A52-AA9F-160CFDD4F344}" type="datetimeFigureOut">
              <a:rPr lang="zh-CN" altLang="en-US" smtClean="0"/>
              <a:t>2021/7/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7024356"/>
            <a:ext cx="4114800" cy="4034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7024356"/>
            <a:ext cx="2743200" cy="4034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0DA816-E5E5-493B-AC71-5BB70D95397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8" y="3917"/>
            <a:ext cx="12192000" cy="3282361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346542" y="51253"/>
            <a:ext cx="68770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ugu1</a:t>
            </a:r>
            <a:endParaRPr lang="zh-CN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1511767" y="63318"/>
            <a:ext cx="66675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wls1</a:t>
            </a:r>
            <a:endParaRPr lang="zh-CN" altLang="en-US" sz="1400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4006682" y="60143"/>
            <a:ext cx="66675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wls1</a:t>
            </a:r>
            <a:endParaRPr lang="zh-CN" altLang="en-US" sz="1400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6351737" y="56333"/>
            <a:ext cx="66675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wls1</a:t>
            </a:r>
            <a:endParaRPr lang="zh-CN" altLang="en-US" sz="1400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8745687" y="48713"/>
            <a:ext cx="66675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wls1</a:t>
            </a:r>
            <a:endParaRPr lang="zh-CN" altLang="en-US" sz="1400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11347917" y="67128"/>
            <a:ext cx="666750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wls1</a:t>
            </a:r>
            <a:endParaRPr lang="zh-CN" altLang="en-US" sz="1400" i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814152" y="48078"/>
            <a:ext cx="68770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ugu1</a:t>
            </a:r>
            <a:endParaRPr lang="zh-CN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5100787" y="38553"/>
            <a:ext cx="68770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ugu1</a:t>
            </a:r>
            <a:endParaRPr lang="zh-CN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7709367" y="41093"/>
            <a:ext cx="68770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ugu1</a:t>
            </a:r>
            <a:endParaRPr lang="zh-CN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0231587" y="43633"/>
            <a:ext cx="687705" cy="30670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ugu1</a:t>
            </a:r>
            <a:endParaRPr lang="zh-CN" altLang="en-US" sz="14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603250" y="3312160"/>
            <a:ext cx="10001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20" name="文本框 19"/>
          <p:cNvSpPr txBox="1"/>
          <p:nvPr/>
        </p:nvSpPr>
        <p:spPr>
          <a:xfrm>
            <a:off x="3178175" y="3296285"/>
            <a:ext cx="10922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5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Cd</a:t>
            </a:r>
          </a:p>
        </p:txBody>
      </p:sp>
      <p:sp>
        <p:nvSpPr>
          <p:cNvPr id="17" name="文本框 16"/>
          <p:cNvSpPr txBox="1"/>
          <p:nvPr/>
        </p:nvSpPr>
        <p:spPr>
          <a:xfrm>
            <a:off x="5581650" y="3299460"/>
            <a:ext cx="1477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5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Cd</a:t>
            </a:r>
          </a:p>
        </p:txBody>
      </p:sp>
      <p:sp>
        <p:nvSpPr>
          <p:cNvPr id="18" name="文本框 17"/>
          <p:cNvSpPr txBox="1"/>
          <p:nvPr/>
        </p:nvSpPr>
        <p:spPr>
          <a:xfrm>
            <a:off x="8115300" y="3274060"/>
            <a:ext cx="1477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Cd</a:t>
            </a:r>
          </a:p>
        </p:txBody>
      </p:sp>
      <p:sp>
        <p:nvSpPr>
          <p:cNvPr id="21" name="文本框 20"/>
          <p:cNvSpPr txBox="1"/>
          <p:nvPr/>
        </p:nvSpPr>
        <p:spPr>
          <a:xfrm>
            <a:off x="10579100" y="3267710"/>
            <a:ext cx="147701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60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 Cd</a:t>
            </a:r>
          </a:p>
        </p:txBody>
      </p:sp>
      <p:graphicFrame>
        <p:nvGraphicFramePr>
          <p:cNvPr id="23" name="图表 22">
            <a:extLst>
              <a:ext uri="{FF2B5EF4-FFF2-40B4-BE49-F238E27FC236}">
                <a16:creationId xmlns:a16="http://schemas.microsoft.com/office/drawing/2014/main" id="{00000000-0008-0000-08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1710605"/>
              </p:ext>
            </p:extLst>
          </p:nvPr>
        </p:nvGraphicFramePr>
        <p:xfrm>
          <a:off x="6077019" y="3741260"/>
          <a:ext cx="5747613" cy="35145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6" name="文本框 25">
            <a:extLst>
              <a:ext uri="{FF2B5EF4-FFF2-40B4-BE49-F238E27FC236}">
                <a16:creationId xmlns:a16="http://schemas.microsoft.com/office/drawing/2014/main" id="{430B129D-BABA-44E6-8D15-17923289D555}"/>
              </a:ext>
            </a:extLst>
          </p:cNvPr>
          <p:cNvSpPr txBox="1"/>
          <p:nvPr/>
        </p:nvSpPr>
        <p:spPr>
          <a:xfrm rot="10800000">
            <a:off x="5963616" y="4433180"/>
            <a:ext cx="431165" cy="167575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lant height (cm)</a:t>
            </a:r>
          </a:p>
        </p:txBody>
      </p:sp>
      <p:graphicFrame>
        <p:nvGraphicFramePr>
          <p:cNvPr id="27" name="图表 26">
            <a:extLst>
              <a:ext uri="{FF2B5EF4-FFF2-40B4-BE49-F238E27FC236}">
                <a16:creationId xmlns:a16="http://schemas.microsoft.com/office/drawing/2014/main" id="{00000000-0008-0000-06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84794578"/>
              </p:ext>
            </p:extLst>
          </p:nvPr>
        </p:nvGraphicFramePr>
        <p:xfrm>
          <a:off x="655895" y="3741260"/>
          <a:ext cx="5698534" cy="35145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5" name="文本框 24">
            <a:extLst>
              <a:ext uri="{FF2B5EF4-FFF2-40B4-BE49-F238E27FC236}">
                <a16:creationId xmlns:a16="http://schemas.microsoft.com/office/drawing/2014/main" id="{FDF0070B-BA95-40A4-8E3B-6A99D949F670}"/>
              </a:ext>
            </a:extLst>
          </p:cNvPr>
          <p:cNvSpPr txBox="1"/>
          <p:nvPr/>
        </p:nvSpPr>
        <p:spPr>
          <a:xfrm rot="10800000">
            <a:off x="818664" y="4433180"/>
            <a:ext cx="431165" cy="179894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oot length (cm)</a:t>
            </a: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E13A1D05-6F16-4D9A-8A98-69A3AFBAB93E}"/>
              </a:ext>
            </a:extLst>
          </p:cNvPr>
          <p:cNvSpPr txBox="1"/>
          <p:nvPr/>
        </p:nvSpPr>
        <p:spPr>
          <a:xfrm rot="10800000">
            <a:off x="6301754" y="4371585"/>
            <a:ext cx="430887" cy="179894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lant height (cm)</a:t>
            </a:r>
          </a:p>
        </p:txBody>
      </p:sp>
      <p:grpSp>
        <p:nvGrpSpPr>
          <p:cNvPr id="30" name="组合 29">
            <a:extLst>
              <a:ext uri="{FF2B5EF4-FFF2-40B4-BE49-F238E27FC236}">
                <a16:creationId xmlns:a16="http://schemas.microsoft.com/office/drawing/2014/main" id="{E42974FA-C88F-4EDA-B090-FDB806642703}"/>
              </a:ext>
            </a:extLst>
          </p:cNvPr>
          <p:cNvGrpSpPr/>
          <p:nvPr/>
        </p:nvGrpSpPr>
        <p:grpSpPr>
          <a:xfrm>
            <a:off x="1359142" y="2915818"/>
            <a:ext cx="972000" cy="307777"/>
            <a:chOff x="1359142" y="2915818"/>
            <a:chExt cx="972000" cy="307777"/>
          </a:xfrm>
        </p:grpSpPr>
        <p:cxnSp>
          <p:nvCxnSpPr>
            <p:cNvPr id="16" name="直接连接符 15">
              <a:extLst>
                <a:ext uri="{FF2B5EF4-FFF2-40B4-BE49-F238E27FC236}">
                  <a16:creationId xmlns:a16="http://schemas.microsoft.com/office/drawing/2014/main" id="{A302173E-E70E-45A8-8141-5FD4B2A08192}"/>
                </a:ext>
              </a:extLst>
            </p:cNvPr>
            <p:cNvCxnSpPr/>
            <p:nvPr/>
          </p:nvCxnSpPr>
          <p:spPr>
            <a:xfrm>
              <a:off x="1359142" y="3190672"/>
              <a:ext cx="972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A663375F-3271-478E-9FF5-9C4F7D49499B}"/>
                </a:ext>
              </a:extLst>
            </p:cNvPr>
            <p:cNvSpPr txBox="1"/>
            <p:nvPr/>
          </p:nvSpPr>
          <p:spPr>
            <a:xfrm>
              <a:off x="1514429" y="2915818"/>
              <a:ext cx="7216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 cm</a:t>
              </a:r>
              <a:endParaRPr lang="zh-CN" alt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" name="组合 30">
            <a:extLst>
              <a:ext uri="{FF2B5EF4-FFF2-40B4-BE49-F238E27FC236}">
                <a16:creationId xmlns:a16="http://schemas.microsoft.com/office/drawing/2014/main" id="{25CD4A5A-7FB6-4937-B879-1817375CA06F}"/>
              </a:ext>
            </a:extLst>
          </p:cNvPr>
          <p:cNvGrpSpPr/>
          <p:nvPr/>
        </p:nvGrpSpPr>
        <p:grpSpPr>
          <a:xfrm>
            <a:off x="3784443" y="2912865"/>
            <a:ext cx="972000" cy="307777"/>
            <a:chOff x="1359142" y="2915818"/>
            <a:chExt cx="972000" cy="307777"/>
          </a:xfrm>
        </p:grpSpPr>
        <p:cxnSp>
          <p:nvCxnSpPr>
            <p:cNvPr id="32" name="直接连接符 31">
              <a:extLst>
                <a:ext uri="{FF2B5EF4-FFF2-40B4-BE49-F238E27FC236}">
                  <a16:creationId xmlns:a16="http://schemas.microsoft.com/office/drawing/2014/main" id="{C7178C01-5063-40D0-91FF-E8C0C614F499}"/>
                </a:ext>
              </a:extLst>
            </p:cNvPr>
            <p:cNvCxnSpPr/>
            <p:nvPr/>
          </p:nvCxnSpPr>
          <p:spPr>
            <a:xfrm>
              <a:off x="1359142" y="3190672"/>
              <a:ext cx="972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01B5A8F1-196F-490B-9080-751BA2117065}"/>
                </a:ext>
              </a:extLst>
            </p:cNvPr>
            <p:cNvSpPr txBox="1"/>
            <p:nvPr/>
          </p:nvSpPr>
          <p:spPr>
            <a:xfrm>
              <a:off x="1514429" y="2915818"/>
              <a:ext cx="7216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 cm</a:t>
              </a:r>
              <a:endParaRPr lang="zh-CN" alt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" name="组合 33">
            <a:extLst>
              <a:ext uri="{FF2B5EF4-FFF2-40B4-BE49-F238E27FC236}">
                <a16:creationId xmlns:a16="http://schemas.microsoft.com/office/drawing/2014/main" id="{BB1B3269-EB50-47DA-A8CA-D109E62FB26D}"/>
              </a:ext>
            </a:extLst>
          </p:cNvPr>
          <p:cNvGrpSpPr/>
          <p:nvPr/>
        </p:nvGrpSpPr>
        <p:grpSpPr>
          <a:xfrm>
            <a:off x="6265158" y="2879942"/>
            <a:ext cx="972000" cy="307777"/>
            <a:chOff x="1359142" y="2915818"/>
            <a:chExt cx="972000" cy="307777"/>
          </a:xfrm>
        </p:grpSpPr>
        <p:cxnSp>
          <p:nvCxnSpPr>
            <p:cNvPr id="35" name="直接连接符 34">
              <a:extLst>
                <a:ext uri="{FF2B5EF4-FFF2-40B4-BE49-F238E27FC236}">
                  <a16:creationId xmlns:a16="http://schemas.microsoft.com/office/drawing/2014/main" id="{810CA5AB-4ABB-49A1-BAE8-C01A13CD3419}"/>
                </a:ext>
              </a:extLst>
            </p:cNvPr>
            <p:cNvCxnSpPr/>
            <p:nvPr/>
          </p:nvCxnSpPr>
          <p:spPr>
            <a:xfrm>
              <a:off x="1359142" y="3190672"/>
              <a:ext cx="972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1E9E6189-9FF2-4441-B16D-9C0C17660AB3}"/>
                </a:ext>
              </a:extLst>
            </p:cNvPr>
            <p:cNvSpPr txBox="1"/>
            <p:nvPr/>
          </p:nvSpPr>
          <p:spPr>
            <a:xfrm>
              <a:off x="1514429" y="2915818"/>
              <a:ext cx="7216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 cm</a:t>
              </a:r>
              <a:endParaRPr lang="zh-CN" alt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" name="组合 36">
            <a:extLst>
              <a:ext uri="{FF2B5EF4-FFF2-40B4-BE49-F238E27FC236}">
                <a16:creationId xmlns:a16="http://schemas.microsoft.com/office/drawing/2014/main" id="{C99C8A4A-4157-418A-983D-53CCF5D4501D}"/>
              </a:ext>
            </a:extLst>
          </p:cNvPr>
          <p:cNvGrpSpPr/>
          <p:nvPr/>
        </p:nvGrpSpPr>
        <p:grpSpPr>
          <a:xfrm>
            <a:off x="8745687" y="2898086"/>
            <a:ext cx="972000" cy="307777"/>
            <a:chOff x="1359142" y="2915818"/>
            <a:chExt cx="972000" cy="307777"/>
          </a:xfrm>
        </p:grpSpPr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id="{8D2B8B49-7061-42A1-8BEB-6D951D6BBB29}"/>
                </a:ext>
              </a:extLst>
            </p:cNvPr>
            <p:cNvCxnSpPr/>
            <p:nvPr/>
          </p:nvCxnSpPr>
          <p:spPr>
            <a:xfrm>
              <a:off x="1359142" y="3190672"/>
              <a:ext cx="972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977E42D9-EF65-4FC8-A3A3-4AFFCDD10BE1}"/>
                </a:ext>
              </a:extLst>
            </p:cNvPr>
            <p:cNvSpPr txBox="1"/>
            <p:nvPr/>
          </p:nvSpPr>
          <p:spPr>
            <a:xfrm>
              <a:off x="1514429" y="2915818"/>
              <a:ext cx="7216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 cm</a:t>
              </a:r>
              <a:endParaRPr lang="zh-CN" alt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" name="组合 39">
            <a:extLst>
              <a:ext uri="{FF2B5EF4-FFF2-40B4-BE49-F238E27FC236}">
                <a16:creationId xmlns:a16="http://schemas.microsoft.com/office/drawing/2014/main" id="{7326C222-E5FE-4699-A518-F181045BDC55}"/>
              </a:ext>
            </a:extLst>
          </p:cNvPr>
          <p:cNvGrpSpPr/>
          <p:nvPr/>
        </p:nvGrpSpPr>
        <p:grpSpPr>
          <a:xfrm>
            <a:off x="11166156" y="2873198"/>
            <a:ext cx="972000" cy="307777"/>
            <a:chOff x="1359142" y="2915818"/>
            <a:chExt cx="972000" cy="307777"/>
          </a:xfrm>
        </p:grpSpPr>
        <p:cxnSp>
          <p:nvCxnSpPr>
            <p:cNvPr id="41" name="直接连接符 40">
              <a:extLst>
                <a:ext uri="{FF2B5EF4-FFF2-40B4-BE49-F238E27FC236}">
                  <a16:creationId xmlns:a16="http://schemas.microsoft.com/office/drawing/2014/main" id="{EEC8D6A2-594E-44D7-ABDA-81101B22B1E8}"/>
                </a:ext>
              </a:extLst>
            </p:cNvPr>
            <p:cNvCxnSpPr/>
            <p:nvPr/>
          </p:nvCxnSpPr>
          <p:spPr>
            <a:xfrm>
              <a:off x="1359142" y="3190672"/>
              <a:ext cx="9720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文本框 41">
              <a:extLst>
                <a:ext uri="{FF2B5EF4-FFF2-40B4-BE49-F238E27FC236}">
                  <a16:creationId xmlns:a16="http://schemas.microsoft.com/office/drawing/2014/main" id="{95955EEA-A4A9-4865-A4DB-E72CD282535E}"/>
                </a:ext>
              </a:extLst>
            </p:cNvPr>
            <p:cNvSpPr txBox="1"/>
            <p:nvPr/>
          </p:nvSpPr>
          <p:spPr>
            <a:xfrm>
              <a:off x="1514429" y="2915818"/>
              <a:ext cx="7216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 cm</a:t>
              </a:r>
              <a:endParaRPr lang="zh-CN" altLang="en-US" sz="14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3" name="文本框 42">
            <a:extLst>
              <a:ext uri="{FF2B5EF4-FFF2-40B4-BE49-F238E27FC236}">
                <a16:creationId xmlns:a16="http://schemas.microsoft.com/office/drawing/2014/main" id="{8CEB7190-E19F-4E92-98B9-68D399D84D85}"/>
              </a:ext>
            </a:extLst>
          </p:cNvPr>
          <p:cNvSpPr txBox="1"/>
          <p:nvPr/>
        </p:nvSpPr>
        <p:spPr>
          <a:xfrm>
            <a:off x="1930070" y="4094626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DB582BEE-962C-4B43-BF10-1B9F41583A5A}"/>
              </a:ext>
            </a:extLst>
          </p:cNvPr>
          <p:cNvSpPr txBox="1"/>
          <p:nvPr/>
        </p:nvSpPr>
        <p:spPr>
          <a:xfrm>
            <a:off x="2777103" y="4371585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0F41009F-6D00-4762-BE85-1A0AB50BF045}"/>
              </a:ext>
            </a:extLst>
          </p:cNvPr>
          <p:cNvSpPr txBox="1"/>
          <p:nvPr/>
        </p:nvSpPr>
        <p:spPr>
          <a:xfrm>
            <a:off x="3595500" y="4561338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D3816851-623B-4977-A1A6-3FA62D891D0A}"/>
              </a:ext>
            </a:extLst>
          </p:cNvPr>
          <p:cNvSpPr txBox="1"/>
          <p:nvPr/>
        </p:nvSpPr>
        <p:spPr>
          <a:xfrm>
            <a:off x="4408616" y="4979679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13E7E14F-1BFD-43B4-B4EC-D791E4314084}"/>
              </a:ext>
            </a:extLst>
          </p:cNvPr>
          <p:cNvSpPr txBox="1"/>
          <p:nvPr/>
        </p:nvSpPr>
        <p:spPr>
          <a:xfrm>
            <a:off x="5211153" y="5271058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4CF08A9E-F5FA-4A47-AFF5-96144FCC7BD6}"/>
              </a:ext>
            </a:extLst>
          </p:cNvPr>
          <p:cNvSpPr txBox="1"/>
          <p:nvPr/>
        </p:nvSpPr>
        <p:spPr>
          <a:xfrm>
            <a:off x="7351194" y="4033031"/>
            <a:ext cx="40107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76561A62-A89F-414E-83FE-644E1DA272B1}"/>
              </a:ext>
            </a:extLst>
          </p:cNvPr>
          <p:cNvSpPr txBox="1"/>
          <p:nvPr/>
        </p:nvSpPr>
        <p:spPr>
          <a:xfrm>
            <a:off x="8238411" y="4095646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BFD53733-3140-4AD0-8225-EA01B16C81B7}"/>
              </a:ext>
            </a:extLst>
          </p:cNvPr>
          <p:cNvSpPr txBox="1"/>
          <p:nvPr/>
        </p:nvSpPr>
        <p:spPr>
          <a:xfrm>
            <a:off x="9079062" y="4222784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6ACDA749-6577-43FE-883F-B9BF62D6972D}"/>
              </a:ext>
            </a:extLst>
          </p:cNvPr>
          <p:cNvSpPr txBox="1"/>
          <p:nvPr/>
        </p:nvSpPr>
        <p:spPr>
          <a:xfrm>
            <a:off x="9919713" y="4365723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AF5FEDB8-B75F-4129-BB5C-87571319A8D4}"/>
              </a:ext>
            </a:extLst>
          </p:cNvPr>
          <p:cNvSpPr txBox="1"/>
          <p:nvPr/>
        </p:nvSpPr>
        <p:spPr>
          <a:xfrm>
            <a:off x="10760364" y="4464274"/>
            <a:ext cx="2648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4</TotalTime>
  <Words>58</Words>
  <Application>Microsoft Office PowerPoint</Application>
  <PresentationFormat>自定义</PresentationFormat>
  <Paragraphs>3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ang Sha</dc:creator>
  <cp:lastModifiedBy>Tang Sha</cp:lastModifiedBy>
  <cp:revision>14</cp:revision>
  <dcterms:created xsi:type="dcterms:W3CDTF">2021-07-05T02:12:00Z</dcterms:created>
  <dcterms:modified xsi:type="dcterms:W3CDTF">2021-07-19T07:20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FE78A5EA417F4534A67A6EBEF9F6C960</vt:lpwstr>
  </property>
  <property fmtid="{D5CDD505-2E9C-101B-9397-08002B2CF9AE}" pid="3" name="KSOProductBuildVer">
    <vt:lpwstr>2052-11.1.0.10578</vt:lpwstr>
  </property>
</Properties>
</file>